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1427" r:id="rId2"/>
    <p:sldId id="1330" r:id="rId3"/>
    <p:sldId id="1423" r:id="rId4"/>
    <p:sldId id="1425" r:id="rId5"/>
    <p:sldId id="1426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4694"/>
  </p:normalViewPr>
  <p:slideViewPr>
    <p:cSldViewPr snapToGrid="0" snapToObjects="1">
      <p:cViewPr varScale="1">
        <p:scale>
          <a:sx n="128" d="100"/>
          <a:sy n="128" d="100"/>
        </p:scale>
        <p:origin x="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7E0DE4-765C-E548-BBDC-FC4D32DD9EE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FEA49CE-FB83-F543-A700-070F6A93A1F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D76DC7-1E9A-534B-9D9C-F9A3D35416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85AB1-CB0D-174C-A3C4-F388B493BE14}" type="datetimeFigureOut">
              <a:rPr lang="en-GB" smtClean="0"/>
              <a:t>03/08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642F32-D56D-0446-A47F-DDFE1C20B2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EAC969-9368-0741-982E-501AF7CD04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CA4484-74E5-D04A-949E-FFA6EB3661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53334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2804F3-64C7-D742-BCB2-6A4FD2918E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88FFA57-75B2-7546-981F-E2827E9405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6BA23F-E029-8941-8DC0-ECD9A2FEB0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85AB1-CB0D-174C-A3C4-F388B493BE14}" type="datetimeFigureOut">
              <a:rPr lang="en-GB" smtClean="0"/>
              <a:t>03/08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9805CA-89F0-B044-B0E5-56E379D251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0EAFDC-E5C0-A742-B969-353C946E3B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CA4484-74E5-D04A-949E-FFA6EB3661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13515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EB5C194-A03A-DD43-A3A2-3690A0D3849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8CCD558-59CC-CC45-8A8D-A526DC9D1C8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A8CD88-CDC3-8948-8A7B-1FA1DE61AE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85AB1-CB0D-174C-A3C4-F388B493BE14}" type="datetimeFigureOut">
              <a:rPr lang="en-GB" smtClean="0"/>
              <a:t>03/08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1A555C-40ED-2F49-B50B-0486DD9828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ACEA16-58B9-074D-BF47-683DAAE484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CA4484-74E5-D04A-949E-FFA6EB3661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5813903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2_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020829" y="-301760"/>
            <a:ext cx="10515600" cy="1325563"/>
          </a:xfrm>
        </p:spPr>
        <p:txBody>
          <a:bodyPr>
            <a:normAutofit/>
          </a:bodyPr>
          <a:lstStyle>
            <a:lvl1pPr>
              <a:defRPr kumimoji="0" lang="en-GB" sz="3600" b="0" i="0" u="none" strike="noStrike" kern="0" cap="none" spc="0" normalizeH="0" baseline="0" dirty="0">
                <a:ln>
                  <a:noFill/>
                </a:ln>
                <a:solidFill>
                  <a:srgbClr val="005D7B"/>
                </a:solidFill>
                <a:effectLst/>
                <a:uLnTx/>
                <a:uFillTx/>
                <a:latin typeface="VAG Rounded"/>
                <a:ea typeface="VAG Rounded"/>
                <a:cs typeface="VAG Rounded"/>
                <a:sym typeface="VAG Rounded"/>
              </a:defRPr>
            </a:lvl1pPr>
          </a:lstStyle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CB0DA-4D43-4874-9E54-B521850362DF}" type="datetimeFigureOut">
              <a:rPr lang="en-GB" smtClean="0"/>
              <a:t>03/08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DCCA0-F74B-4108-B120-EB74107E44B5}" type="slidenum">
              <a:rPr lang="en-GB" smtClean="0"/>
              <a:t>‹#›</a:t>
            </a:fld>
            <a:endParaRPr lang="en-GB"/>
          </a:p>
        </p:txBody>
      </p:sp>
      <p:sp>
        <p:nvSpPr>
          <p:cNvPr id="8" name="Rectangle 1"/>
          <p:cNvSpPr/>
          <p:nvPr userDrawn="1"/>
        </p:nvSpPr>
        <p:spPr>
          <a:xfrm>
            <a:off x="0" y="5753100"/>
            <a:ext cx="12192000" cy="1104898"/>
          </a:xfrm>
          <a:prstGeom prst="rect">
            <a:avLst/>
          </a:prstGeom>
          <a:solidFill>
            <a:srgbClr val="005D7B"/>
          </a:solidFill>
          <a:ln w="12700">
            <a:solidFill>
              <a:srgbClr val="42719B"/>
            </a:solidFill>
            <a:miter/>
          </a:ln>
        </p:spPr>
        <p:txBody>
          <a:bodyPr lIns="45719" rIns="45719" anchor="ctr"/>
          <a:lstStyle/>
          <a:p>
            <a:pPr marL="0" marR="0" lvl="0" indent="0" algn="ctr" defTabSz="914400" rtl="0" eaLnBrk="1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>
                <a:solidFill>
                  <a:srgbClr val="FFFFFF"/>
                </a:solidFill>
              </a:defRPr>
            </a:pPr>
            <a:endParaRPr kumimoji="0" sz="1800" b="0" i="0" u="none" strike="noStrike" kern="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Calibri"/>
              <a:cs typeface="Calibri"/>
              <a:sym typeface="Calibri"/>
            </a:endParaRPr>
          </a:p>
        </p:txBody>
      </p:sp>
      <p:pic>
        <p:nvPicPr>
          <p:cNvPr id="9" name="Picture 10" descr="Picture 10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0" y="1"/>
            <a:ext cx="1133341" cy="818601"/>
          </a:xfrm>
          <a:prstGeom prst="rect">
            <a:avLst/>
          </a:prstGeom>
          <a:ln w="12700">
            <a:miter lim="400000"/>
          </a:ln>
        </p:spPr>
      </p:pic>
      <p:pic>
        <p:nvPicPr>
          <p:cNvPr id="13" name="Picture 2" descr="Picture 2"/>
          <p:cNvPicPr>
            <a:picLocks noChangeAspect="1"/>
          </p:cNvPicPr>
          <p:nvPr userDrawn="1"/>
        </p:nvPicPr>
        <p:blipFill>
          <a:blip r:embed="rId3"/>
          <a:srcRect l="30998" t="4241" r="33466" b="4096"/>
          <a:stretch>
            <a:fillRect/>
          </a:stretch>
        </p:blipFill>
        <p:spPr>
          <a:xfrm>
            <a:off x="2640273" y="628927"/>
            <a:ext cx="3432665" cy="6106727"/>
          </a:xfrm>
          <a:prstGeom prst="rect">
            <a:avLst/>
          </a:prstGeom>
          <a:ln w="12700">
            <a:miter lim="400000"/>
          </a:ln>
        </p:spPr>
      </p:pic>
      <p:pic>
        <p:nvPicPr>
          <p:cNvPr id="14" name="Picture 2" descr="Picture 2"/>
          <p:cNvPicPr>
            <a:picLocks noChangeAspect="1"/>
          </p:cNvPicPr>
          <p:nvPr userDrawn="1"/>
        </p:nvPicPr>
        <p:blipFill>
          <a:blip r:embed="rId3"/>
          <a:srcRect l="30998" t="4241" r="33466" b="4096"/>
          <a:stretch>
            <a:fillRect/>
          </a:stretch>
        </p:blipFill>
        <p:spPr>
          <a:xfrm>
            <a:off x="5710309" y="628927"/>
            <a:ext cx="3422159" cy="6106727"/>
          </a:xfrm>
          <a:prstGeom prst="rect">
            <a:avLst/>
          </a:prstGeom>
          <a:ln w="12700">
            <a:miter lim="400000"/>
          </a:ln>
        </p:spPr>
      </p:pic>
      <p:sp>
        <p:nvSpPr>
          <p:cNvPr id="18" name="Rectangle 3"/>
          <p:cNvSpPr/>
          <p:nvPr userDrawn="1"/>
        </p:nvSpPr>
        <p:spPr>
          <a:xfrm>
            <a:off x="10434391" y="5753100"/>
            <a:ext cx="1757609" cy="1104900"/>
          </a:xfrm>
          <a:custGeom>
            <a:avLst/>
            <a:gdLst/>
            <a:ahLst/>
            <a:cxnLst>
              <a:cxn ang="0">
                <a:pos x="wd2" y="hd2"/>
              </a:cxn>
              <a:cxn ang="5400000">
                <a:pos x="wd2" y="hd2"/>
              </a:cxn>
              <a:cxn ang="10800000">
                <a:pos x="wd2" y="hd2"/>
              </a:cxn>
              <a:cxn ang="16200000">
                <a:pos x="wd2" y="hd2"/>
              </a:cxn>
            </a:cxnLst>
            <a:rect l="0" t="0" r="r" b="b"/>
            <a:pathLst>
              <a:path w="21600" h="21600" extrusionOk="0">
                <a:moveTo>
                  <a:pt x="4432" y="0"/>
                </a:moveTo>
                <a:lnTo>
                  <a:pt x="21600" y="0"/>
                </a:lnTo>
                <a:lnTo>
                  <a:pt x="21600" y="21600"/>
                </a:lnTo>
                <a:lnTo>
                  <a:pt x="0" y="21600"/>
                </a:lnTo>
                <a:lnTo>
                  <a:pt x="4432" y="0"/>
                </a:lnTo>
                <a:close/>
              </a:path>
            </a:pathLst>
          </a:custGeom>
          <a:solidFill>
            <a:srgbClr val="006600"/>
          </a:solidFill>
          <a:ln w="12700">
            <a:miter lim="400000"/>
          </a:ln>
        </p:spPr>
        <p:txBody>
          <a:bodyPr lIns="45719" rIns="45719" anchor="ctr"/>
          <a:lstStyle/>
          <a:p>
            <a:pPr marL="0" marR="0" lvl="0" indent="0" algn="ctr" defTabSz="914400" rtl="0" eaLnBrk="1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>
                <a:solidFill>
                  <a:srgbClr val="FFFFFF"/>
                </a:solidFill>
              </a:defRPr>
            </a:pPr>
            <a:endParaRPr kumimoji="0" sz="1800" b="0" i="0" u="none" strike="noStrike" kern="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Calibri"/>
              <a:cs typeface="Calibri"/>
              <a:sym typeface="Calibri"/>
            </a:endParaRPr>
          </a:p>
        </p:txBody>
      </p:sp>
      <p:pic>
        <p:nvPicPr>
          <p:cNvPr id="19" name="Picture 18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16747" y="5998027"/>
            <a:ext cx="1434291" cy="737627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 userDrawn="1"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9333" y="5991898"/>
            <a:ext cx="2109059" cy="7359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332479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599819-C437-894D-8BA3-B712C3DF75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0F8169D-F61B-AD4F-B330-D111B0DE753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272AC6-8106-D743-8E76-679548333E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85AB1-CB0D-174C-A3C4-F388B493BE14}" type="datetimeFigureOut">
              <a:rPr lang="en-GB" smtClean="0"/>
              <a:t>03/08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0FB272-B948-D34F-BAD9-7D3A15A602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774C59-DAA0-3942-B0FF-2D0C9FF6D9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CA4484-74E5-D04A-949E-FFA6EB3661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11719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848C6F-6861-1F4E-B06F-84F81A29DA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977167E-B054-224A-887C-64F1CF7AA4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266B19-7CD1-684E-A866-6C12A61C42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85AB1-CB0D-174C-A3C4-F388B493BE14}" type="datetimeFigureOut">
              <a:rPr lang="en-GB" smtClean="0"/>
              <a:t>03/08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A092F8-FF06-F84E-9477-0D2C4211BA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94C5A7-70DB-4744-81AA-402ABF9AB7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CA4484-74E5-D04A-949E-FFA6EB3661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36543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B1DC87-E1B7-EF42-A75B-5A4899E83A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FFC5A5F-1AA5-314B-9719-67826307E0E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78B6CE2-88C9-0349-8C0B-DBD4817831E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6A64C7C-4551-E04A-A7A3-F0D5F73A0E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85AB1-CB0D-174C-A3C4-F388B493BE14}" type="datetimeFigureOut">
              <a:rPr lang="en-GB" smtClean="0"/>
              <a:t>03/08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CFDE574-B22B-234D-9D66-FE2F634455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84DC6F9-040B-1C4B-9BD0-7314071694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CA4484-74E5-D04A-949E-FFA6EB3661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78023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4DE889-CEB2-044C-9EBA-9E8E193F69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10F1BCF-5B2B-6842-BF32-8E79605911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37E9D61-59AA-2048-8A18-677BC0B0EE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A69E2C8-BA3F-FF4C-B120-86676FBA91E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14C5B1C-22F6-E74B-A88B-2A10AB00155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F73BD8E-017D-3649-8130-02F673C221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85AB1-CB0D-174C-A3C4-F388B493BE14}" type="datetimeFigureOut">
              <a:rPr lang="en-GB" smtClean="0"/>
              <a:t>03/08/2020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040B330-2C2B-8349-91B7-F0C64B9FCE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ADA24B3-F5DF-8D44-AF64-DBF114B012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CA4484-74E5-D04A-949E-FFA6EB3661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15493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4E640B-2946-E440-9A76-C575D624C1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10B01C7-7D50-BC47-8A86-BDD1EEA73E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85AB1-CB0D-174C-A3C4-F388B493BE14}" type="datetimeFigureOut">
              <a:rPr lang="en-GB" smtClean="0"/>
              <a:t>03/08/2020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019FCD7-3555-5343-999B-043BA72CEA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1629B74-6FF2-F64C-A68B-FF7DBC7D36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CA4484-74E5-D04A-949E-FFA6EB3661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83226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1994B0D-AB41-6D44-8786-8A61FC645E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85AB1-CB0D-174C-A3C4-F388B493BE14}" type="datetimeFigureOut">
              <a:rPr lang="en-GB" smtClean="0"/>
              <a:t>03/08/2020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DA2AABD-0CE3-B846-9A3B-88BE789DFB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A4624ED-D14A-5E4A-A8B8-B77E0850A5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CA4484-74E5-D04A-949E-FFA6EB3661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31319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8FA4F7-1168-8643-800B-8F14707D45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3881E2-F2F4-8C42-B03C-A96448E7F90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60D5AEC-ADEB-1C4C-A572-FB6A684A8BC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08CB201-DA37-B24F-9312-4E590CCE96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85AB1-CB0D-174C-A3C4-F388B493BE14}" type="datetimeFigureOut">
              <a:rPr lang="en-GB" smtClean="0"/>
              <a:t>03/08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85BBB3-8B33-1A42-8F2D-132C6FBA23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B4D2BA3-66FB-FB44-9D66-A6B8ED2DF9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CA4484-74E5-D04A-949E-FFA6EB3661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76807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C742D7-F52C-C74A-96C9-C4B7ADD6F3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70C7E3F-75C9-9446-9622-6D624ADA1C4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4BFDE15-C94E-F74A-B9E1-7C57016ED76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53E6A71-9E71-D741-92D7-FE90FF0CD9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85AB1-CB0D-174C-A3C4-F388B493BE14}" type="datetimeFigureOut">
              <a:rPr lang="en-GB" smtClean="0"/>
              <a:t>03/08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E64F43A-41B8-B344-976F-AFC34F0476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830629-E6DA-064E-A9AF-B7276C5900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CA4484-74E5-D04A-949E-FFA6EB3661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32919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66231B8-A10E-CC48-BB3A-C5A2AD8048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EE60CF-0A94-C246-99F0-A556F1B526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504914-7E6E-9442-A399-403C42AD44D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085AB1-CB0D-174C-A3C4-F388B493BE14}" type="datetimeFigureOut">
              <a:rPr lang="en-GB" smtClean="0"/>
              <a:t>03/08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095DA6-0DAC-9B49-B8E8-47DB4FBE8E3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8823EA-82F9-544E-88A2-514B2037617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CA4484-74E5-D04A-949E-FFA6EB3661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07827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2.xml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2.xml"/><Relationship Id="rId4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2.xml"/><Relationship Id="rId4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07FEBE-6D5B-DA4C-A379-78EE57E3A7B3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MM1: Baby Buddy features.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357866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/>
          <p:cNvSpPr>
            <a:spLocks noGrp="1"/>
          </p:cNvSpPr>
          <p:nvPr>
            <p:ph type="title"/>
          </p:nvPr>
        </p:nvSpPr>
        <p:spPr>
          <a:xfrm>
            <a:off x="3450265" y="-280494"/>
            <a:ext cx="10515600" cy="1325563"/>
          </a:xfrm>
        </p:spPr>
        <p:txBody>
          <a:bodyPr/>
          <a:lstStyle/>
          <a:p>
            <a:r>
              <a:rPr lang="en-GB" dirty="0"/>
              <a:t>Baby Buddy Features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20829" y="1467355"/>
            <a:ext cx="2561264" cy="4400045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6047766" y="1467355"/>
            <a:ext cx="2660299" cy="44000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17878364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5" descr="Picture 1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33915" y="1433216"/>
            <a:ext cx="2573828" cy="4109093"/>
          </a:xfrm>
          <a:prstGeom prst="rect">
            <a:avLst/>
          </a:prstGeom>
          <a:ln w="12700">
            <a:miter lim="400000"/>
          </a:ln>
        </p:spPr>
      </p:pic>
      <p:pic>
        <p:nvPicPr>
          <p:cNvPr id="14" name="Picture 16" descr="Picture 1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25443" y="1696985"/>
            <a:ext cx="2542046" cy="4169159"/>
          </a:xfrm>
          <a:prstGeom prst="rect">
            <a:avLst/>
          </a:prstGeom>
          <a:ln w="12700">
            <a:miter lim="400000"/>
          </a:ln>
        </p:spPr>
      </p:pic>
      <p:pic>
        <p:nvPicPr>
          <p:cNvPr id="15" name="Picture 18" descr="Picture 1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824890" y="1433216"/>
            <a:ext cx="2476913" cy="4095078"/>
          </a:xfrm>
          <a:prstGeom prst="rect">
            <a:avLst/>
          </a:prstGeom>
          <a:ln w="12700">
            <a:miter lim="400000"/>
          </a:ln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78154" y="-235085"/>
            <a:ext cx="10515600" cy="1325563"/>
          </a:xfrm>
        </p:spPr>
        <p:txBody>
          <a:bodyPr/>
          <a:lstStyle/>
          <a:p>
            <a:r>
              <a:rPr lang="en-GB" dirty="0"/>
              <a:t>Over 300 videos</a:t>
            </a:r>
          </a:p>
        </p:txBody>
      </p:sp>
    </p:spTree>
    <p:extLst>
      <p:ext uri="{BB962C8B-B14F-4D97-AF65-F5344CB8AC3E}">
        <p14:creationId xmlns:p14="http://schemas.microsoft.com/office/powerpoint/2010/main" val="29437183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itle 1"/>
          <p:cNvSpPr txBox="1"/>
          <p:nvPr/>
        </p:nvSpPr>
        <p:spPr>
          <a:xfrm>
            <a:off x="2287856" y="60051"/>
            <a:ext cx="6878320" cy="59093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square" lIns="45719" rIns="45719">
            <a:spAutoFit/>
          </a:bodyPr>
          <a:lstStyle>
            <a:lvl1pPr>
              <a:lnSpc>
                <a:spcPct val="90000"/>
              </a:lnSpc>
              <a:defRPr sz="3600">
                <a:solidFill>
                  <a:srgbClr val="005D7B"/>
                </a:solidFill>
                <a:latin typeface="VAG Rounded Std"/>
                <a:ea typeface="VAG Rounded Std"/>
                <a:cs typeface="VAG Rounded Std"/>
                <a:sym typeface="VAG Rounded Std"/>
              </a:defRPr>
            </a:lvl1pPr>
          </a:lstStyle>
          <a:p>
            <a:pPr marL="0" marR="0" lvl="0" indent="0" algn="l" defTabSz="914400" rtl="0" eaLnBrk="1" fontAlgn="auto" latinLnBrk="0" hangingPunct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sz="3600" b="0" i="0" u="none" strike="noStrike" kern="0" cap="none" spc="0" normalizeH="0" baseline="0" noProof="0" dirty="0" err="1">
                <a:ln>
                  <a:noFill/>
                </a:ln>
                <a:solidFill>
                  <a:srgbClr val="005D7B"/>
                </a:solidFill>
                <a:effectLst/>
                <a:uLnTx/>
                <a:uFillTx/>
                <a:latin typeface="VAG Rounded Std"/>
                <a:sym typeface="VAG Rounded Std"/>
              </a:rPr>
              <a:t>Personalised</a:t>
            </a:r>
            <a:r>
              <a:rPr kumimoji="0" sz="3600" b="0" i="0" u="none" strike="noStrike" kern="0" cap="none" spc="0" normalizeH="0" baseline="0" noProof="0" dirty="0">
                <a:ln>
                  <a:noFill/>
                </a:ln>
                <a:solidFill>
                  <a:srgbClr val="005D7B"/>
                </a:solidFill>
                <a:effectLst/>
                <a:uLnTx/>
                <a:uFillTx/>
                <a:latin typeface="VAG Rounded Std"/>
                <a:sym typeface="VAG Rounded Std"/>
              </a:rPr>
              <a:t> “Daily information”</a:t>
            </a:r>
          </a:p>
        </p:txBody>
      </p:sp>
      <p:pic>
        <p:nvPicPr>
          <p:cNvPr id="17" name="Picture 15" descr="Picture 1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57588" y="1409700"/>
            <a:ext cx="2528645" cy="4039674"/>
          </a:xfrm>
          <a:prstGeom prst="rect">
            <a:avLst/>
          </a:prstGeom>
          <a:ln w="12700">
            <a:miter lim="400000"/>
          </a:ln>
        </p:spPr>
      </p:pic>
      <p:pic>
        <p:nvPicPr>
          <p:cNvPr id="18" name="Picture 16" descr="Picture 16"/>
          <p:cNvPicPr>
            <a:picLocks noChangeAspect="1"/>
          </p:cNvPicPr>
          <p:nvPr/>
        </p:nvPicPr>
        <p:blipFill>
          <a:blip r:embed="rId3"/>
          <a:srcRect l="31764" t="18150" r="34815" b="20612"/>
          <a:stretch>
            <a:fillRect/>
          </a:stretch>
        </p:blipFill>
        <p:spPr>
          <a:xfrm>
            <a:off x="4759857" y="1838280"/>
            <a:ext cx="2530362" cy="4082604"/>
          </a:xfrm>
          <a:prstGeom prst="rect">
            <a:avLst/>
          </a:prstGeom>
          <a:ln w="12700">
            <a:miter lim="400000"/>
          </a:ln>
        </p:spPr>
      </p:pic>
      <p:pic>
        <p:nvPicPr>
          <p:cNvPr id="19" name="Picture 3" descr="Picture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789243" y="1409700"/>
            <a:ext cx="2510457" cy="4083877"/>
          </a:xfrm>
          <a:prstGeom prst="rect">
            <a:avLst/>
          </a:prstGeom>
          <a:ln w="12700">
            <a:miter lim="400000"/>
          </a:ln>
        </p:spPr>
      </p:pic>
    </p:spTree>
    <p:extLst>
      <p:ext uri="{BB962C8B-B14F-4D97-AF65-F5344CB8AC3E}">
        <p14:creationId xmlns:p14="http://schemas.microsoft.com/office/powerpoint/2010/main" val="176047686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 descr="Picture 1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83887" y="1436415"/>
            <a:ext cx="2573155" cy="4063222"/>
          </a:xfrm>
          <a:prstGeom prst="rect">
            <a:avLst/>
          </a:prstGeom>
          <a:ln w="12700">
            <a:miter lim="400000"/>
          </a:ln>
        </p:spPr>
      </p:pic>
      <p:pic>
        <p:nvPicPr>
          <p:cNvPr id="14" name="Picture 13" descr="Picture 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72035" y="1776459"/>
            <a:ext cx="2544625" cy="4093805"/>
          </a:xfrm>
          <a:prstGeom prst="rect">
            <a:avLst/>
          </a:prstGeom>
          <a:ln w="12700">
            <a:miter lim="400000"/>
          </a:ln>
        </p:spPr>
      </p:pic>
      <p:pic>
        <p:nvPicPr>
          <p:cNvPr id="15" name="Picture 14" descr="Picture 1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831653" y="1436415"/>
            <a:ext cx="2532926" cy="4063222"/>
          </a:xfrm>
          <a:prstGeom prst="rect">
            <a:avLst/>
          </a:prstGeom>
          <a:ln w="12700">
            <a:miter lim="400000"/>
          </a:ln>
        </p:spPr>
      </p:pic>
      <p:sp>
        <p:nvSpPr>
          <p:cNvPr id="16" name="Title 1"/>
          <p:cNvSpPr txBox="1"/>
          <p:nvPr/>
        </p:nvSpPr>
        <p:spPr>
          <a:xfrm>
            <a:off x="2287856" y="0"/>
            <a:ext cx="6878320" cy="59093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square" lIns="45719" rIns="45719">
            <a:spAutoFit/>
          </a:bodyPr>
          <a:lstStyle>
            <a:lvl1pPr>
              <a:lnSpc>
                <a:spcPct val="90000"/>
              </a:lnSpc>
              <a:defRPr sz="3600">
                <a:solidFill>
                  <a:srgbClr val="005D7B"/>
                </a:solidFill>
                <a:latin typeface="VAG Rounded Std"/>
                <a:ea typeface="VAG Rounded Std"/>
                <a:cs typeface="VAG Rounded Std"/>
                <a:sym typeface="VAG Rounded Std"/>
              </a:defRPr>
            </a:lvl1pPr>
          </a:lstStyle>
          <a:p>
            <a:pPr marL="0" marR="0" lvl="0" indent="0" algn="l" defTabSz="914400" rtl="0" eaLnBrk="1" fontAlgn="auto" latinLnBrk="0" hangingPunct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sz="3600" b="0" i="0" u="none" strike="noStrike" kern="0" cap="none" spc="0" normalizeH="0" baseline="0" noProof="0" dirty="0" err="1">
                <a:ln>
                  <a:noFill/>
                </a:ln>
                <a:solidFill>
                  <a:srgbClr val="005D7B"/>
                </a:solidFill>
                <a:effectLst/>
                <a:uLnTx/>
                <a:uFillTx/>
                <a:latin typeface="VAG Rounded Std"/>
                <a:sym typeface="VAG Rounded Std"/>
              </a:rPr>
              <a:t>Personalised</a:t>
            </a:r>
            <a:r>
              <a:rPr kumimoji="0" sz="3600" b="0" i="0" u="none" strike="noStrike" kern="0" cap="none" spc="0" normalizeH="0" baseline="0" noProof="0" dirty="0">
                <a:ln>
                  <a:noFill/>
                </a:ln>
                <a:solidFill>
                  <a:srgbClr val="005D7B"/>
                </a:solidFill>
                <a:effectLst/>
                <a:uLnTx/>
                <a:uFillTx/>
                <a:latin typeface="VAG Rounded Std"/>
                <a:sym typeface="VAG Rounded Std"/>
              </a:rPr>
              <a:t> “Daily information”</a:t>
            </a:r>
          </a:p>
        </p:txBody>
      </p:sp>
    </p:spTree>
    <p:extLst>
      <p:ext uri="{BB962C8B-B14F-4D97-AF65-F5344CB8AC3E}">
        <p14:creationId xmlns:p14="http://schemas.microsoft.com/office/powerpoint/2010/main" val="24871063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2</Words>
  <Application>Microsoft Macintosh PowerPoint</Application>
  <PresentationFormat>Widescreen</PresentationFormat>
  <Paragraphs>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VAG Rounded</vt:lpstr>
      <vt:lpstr>VAG Rounded Std</vt:lpstr>
      <vt:lpstr>Office Theme</vt:lpstr>
      <vt:lpstr>MM1: Baby Buddy features.</vt:lpstr>
      <vt:lpstr>Baby Buddy Features</vt:lpstr>
      <vt:lpstr>Over 300 videos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Baby Buddy Features</dc:title>
  <dc:creator>Rhodes, Alexandra</dc:creator>
  <cp:lastModifiedBy>Rhodes, Alexandra</cp:lastModifiedBy>
  <cp:revision>2</cp:revision>
  <dcterms:created xsi:type="dcterms:W3CDTF">2020-07-26T17:30:32Z</dcterms:created>
  <dcterms:modified xsi:type="dcterms:W3CDTF">2020-08-03T12:05:03Z</dcterms:modified>
</cp:coreProperties>
</file>